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6858000" cy="9144000"/>
  <p:notesSz cx="6948488" cy="92694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40DC18-AD61-45F2-B642-9E6A70D418E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2D05A9-2530-45D0-B362-C6418D867B6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5EF0C7-8D52-443A-95B7-7A2B43C3319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6B571C-0004-4576-9DEF-D66F70F017C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311D05-9422-41E4-976E-3B59FD6B64D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027DF1-C6F9-439C-87A3-C8D272E08A2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9DB624-DFF0-4524-ADE5-9BE7364A42A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BFC7C2-9DED-4F21-852F-4A1ADBA5BAC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51D7AC-1052-43F1-89AA-DAB193A9304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0454CB-2EC1-4DD1-A601-E65613A99A3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A7F051-08E9-47BB-BA9C-2F606E6445F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6BA34B-2144-46D6-9C8E-7B7E57EAB6D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F2349B0-C005-421F-9099-DAA99E49F56D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image" Target="../media/image3.png"/><Relationship Id="rId3" Type="http://schemas.openxmlformats.org/officeDocument/2006/relationships/image" Target="../media/image4.png"/><Relationship Id="rId4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6"/>
          <p:cNvSpPr/>
          <p:nvPr/>
        </p:nvSpPr>
        <p:spPr>
          <a:xfrm>
            <a:off x="155520" y="152280"/>
            <a:ext cx="1054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igure S2.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Picture 18" descr="New 12wk WT NT vs KO NT  IPA Network1"/>
          <p:cNvPicPr/>
          <p:nvPr/>
        </p:nvPicPr>
        <p:blipFill>
          <a:blip r:embed="rId1"/>
          <a:stretch/>
        </p:blipFill>
        <p:spPr>
          <a:xfrm>
            <a:off x="304920" y="1143000"/>
            <a:ext cx="5638680" cy="4921200"/>
          </a:xfrm>
          <a:prstGeom prst="rect">
            <a:avLst/>
          </a:prstGeom>
          <a:ln w="0">
            <a:noFill/>
          </a:ln>
        </p:spPr>
      </p:pic>
      <p:sp>
        <p:nvSpPr>
          <p:cNvPr id="43" name="Text Box 20"/>
          <p:cNvSpPr/>
          <p:nvPr/>
        </p:nvSpPr>
        <p:spPr>
          <a:xfrm>
            <a:off x="213480" y="871560"/>
            <a:ext cx="5999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. Top functional network of Nrf2-dependent lung genes at 12 wk after urethane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 Box 21"/>
          <p:cNvSpPr/>
          <p:nvPr/>
        </p:nvSpPr>
        <p:spPr>
          <a:xfrm>
            <a:off x="225000" y="1219320"/>
            <a:ext cx="53301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ell-To-Cell Signaling and Interaction, Connective Tissue Development and Function, Ophthalmic Diseas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(Score 54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Text Box 4"/>
          <p:cNvSpPr/>
          <p:nvPr/>
        </p:nvSpPr>
        <p:spPr>
          <a:xfrm>
            <a:off x="2520" y="838080"/>
            <a:ext cx="6081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B. Top functional networks of Nrf2-dependent genes in urethane-induced tumor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6" name="Picture 11" descr="new WT vs KO Tumor 22 wk netwrok 3"/>
          <p:cNvPicPr/>
          <p:nvPr/>
        </p:nvPicPr>
        <p:blipFill>
          <a:blip r:embed="rId1"/>
          <a:stretch/>
        </p:blipFill>
        <p:spPr>
          <a:xfrm>
            <a:off x="0" y="4724280"/>
            <a:ext cx="3352680" cy="3353040"/>
          </a:xfrm>
          <a:prstGeom prst="rect">
            <a:avLst/>
          </a:prstGeom>
          <a:ln w="0">
            <a:noFill/>
          </a:ln>
        </p:spPr>
      </p:pic>
      <p:pic>
        <p:nvPicPr>
          <p:cNvPr id="47" name="Picture 12" descr="new WT vs KO Tumor 22 wk netwrok 1"/>
          <p:cNvPicPr/>
          <p:nvPr/>
        </p:nvPicPr>
        <p:blipFill>
          <a:blip r:embed="rId2"/>
          <a:stretch/>
        </p:blipFill>
        <p:spPr>
          <a:xfrm>
            <a:off x="0" y="1219320"/>
            <a:ext cx="3303720" cy="3504960"/>
          </a:xfrm>
          <a:prstGeom prst="rect">
            <a:avLst/>
          </a:prstGeom>
          <a:ln w="0">
            <a:noFill/>
          </a:ln>
        </p:spPr>
      </p:pic>
      <p:sp>
        <p:nvSpPr>
          <p:cNvPr id="48" name="Text Box 13"/>
          <p:cNvSpPr/>
          <p:nvPr/>
        </p:nvSpPr>
        <p:spPr>
          <a:xfrm>
            <a:off x="-75240" y="1219320"/>
            <a:ext cx="33523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ell cycle, Cancer, Connective Tissue Development and Functio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(Score 43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9" name="Picture 15" descr="new WT vs KO Tumor 22 wk netwrok 2"/>
          <p:cNvPicPr/>
          <p:nvPr/>
        </p:nvPicPr>
        <p:blipFill>
          <a:blip r:embed="rId3"/>
          <a:srcRect l="1929" t="0" r="0" b="0"/>
          <a:stretch/>
        </p:blipFill>
        <p:spPr>
          <a:xfrm>
            <a:off x="3271680" y="1219320"/>
            <a:ext cx="3586320" cy="3395520"/>
          </a:xfrm>
          <a:prstGeom prst="rect">
            <a:avLst/>
          </a:prstGeom>
          <a:ln w="0">
            <a:noFill/>
          </a:ln>
        </p:spPr>
      </p:pic>
      <p:sp>
        <p:nvSpPr>
          <p:cNvPr id="50" name="Text Box 16"/>
          <p:cNvSpPr/>
          <p:nvPr/>
        </p:nvSpPr>
        <p:spPr>
          <a:xfrm>
            <a:off x="3196440" y="1219320"/>
            <a:ext cx="3754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ell-To-Cell Signaling and Interaction, Tissue Development, Cell Functio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(Score 38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 Box 17"/>
          <p:cNvSpPr/>
          <p:nvPr/>
        </p:nvSpPr>
        <p:spPr>
          <a:xfrm>
            <a:off x="-78840" y="4724280"/>
            <a:ext cx="3553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Tumor Morphology, Cancer, Dermatological Diseases and Condition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(Score 38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Text Box 4"/>
          <p:cNvSpPr/>
          <p:nvPr/>
        </p:nvSpPr>
        <p:spPr>
          <a:xfrm>
            <a:off x="122040" y="762120"/>
            <a:ext cx="55148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. Top functional network of Nrf2-dependent genes changed by urethane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In pre-neoplatic stage (12 wk) and in tumors (22 wk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3" name="Picture 7" descr="Wt vs KO 12wk UN-22wk Tumor common 21 gene network 1"/>
          <p:cNvPicPr/>
          <p:nvPr/>
        </p:nvPicPr>
        <p:blipFill>
          <a:blip r:embed="rId1"/>
          <a:stretch/>
        </p:blipFill>
        <p:spPr>
          <a:xfrm>
            <a:off x="228600" y="1143000"/>
            <a:ext cx="5111640" cy="5715000"/>
          </a:xfrm>
          <a:prstGeom prst="rect">
            <a:avLst/>
          </a:prstGeom>
          <a:ln w="0">
            <a:noFill/>
          </a:ln>
        </p:spPr>
      </p:pic>
      <p:sp>
        <p:nvSpPr>
          <p:cNvPr id="54" name="Text Box 8"/>
          <p:cNvSpPr/>
          <p:nvPr/>
        </p:nvSpPr>
        <p:spPr>
          <a:xfrm>
            <a:off x="154800" y="1219320"/>
            <a:ext cx="1626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ancer, Cell Cycle, Cell Death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(Score 23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7-12T19:40:40Z</dcterms:created>
  <dc:creator>cho2</dc:creator>
  <dc:description/>
  <dc:language>en-US</dc:language>
  <cp:lastModifiedBy>College of Vet Med</cp:lastModifiedBy>
  <dcterms:modified xsi:type="dcterms:W3CDTF">2011-04-08T02:13:11Z</dcterms:modified>
  <cp:revision>17</cp:revision>
  <dc:subject/>
  <dc:title>Slide 1</dc:title>
</cp:coreProperties>
</file>